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8" r:id="rId2"/>
    <p:sldId id="273" r:id="rId3"/>
    <p:sldId id="274" r:id="rId4"/>
    <p:sldId id="272" r:id="rId5"/>
    <p:sldId id="271" r:id="rId6"/>
    <p:sldId id="270" r:id="rId7"/>
    <p:sldId id="269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99" autoAdjust="0"/>
    <p:restoredTop sz="94669"/>
  </p:normalViewPr>
  <p:slideViewPr>
    <p:cSldViewPr snapToGrid="0">
      <p:cViewPr varScale="1">
        <p:scale>
          <a:sx n="113" d="100"/>
          <a:sy n="113" d="100"/>
        </p:scale>
        <p:origin x="20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D125-7F42-49FA-BE41-4656495FE582}" type="datetimeFigureOut">
              <a:rPr lang="zh-CN" altLang="en-US" smtClean="0"/>
              <a:t>2025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5C7B-385F-4B2B-89D4-DBADEA4BF6F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D125-7F42-49FA-BE41-4656495FE582}" type="datetimeFigureOut">
              <a:rPr lang="zh-CN" altLang="en-US" smtClean="0"/>
              <a:t>2025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5C7B-385F-4B2B-89D4-DBADEA4BF6F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D125-7F42-49FA-BE41-4656495FE582}" type="datetimeFigureOut">
              <a:rPr lang="zh-CN" altLang="en-US" smtClean="0"/>
              <a:t>2025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5C7B-385F-4B2B-89D4-DBADEA4BF6F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D125-7F42-49FA-BE41-4656495FE582}" type="datetimeFigureOut">
              <a:rPr lang="zh-CN" altLang="en-US" smtClean="0"/>
              <a:t>2025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5C7B-385F-4B2B-89D4-DBADEA4BF6F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D125-7F42-49FA-BE41-4656495FE582}" type="datetimeFigureOut">
              <a:rPr lang="zh-CN" altLang="en-US" smtClean="0"/>
              <a:t>2025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5C7B-385F-4B2B-89D4-DBADEA4BF6F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D125-7F42-49FA-BE41-4656495FE582}" type="datetimeFigureOut">
              <a:rPr lang="zh-CN" altLang="en-US" smtClean="0"/>
              <a:t>2025/3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5C7B-385F-4B2B-89D4-DBADEA4BF6F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D125-7F42-49FA-BE41-4656495FE582}" type="datetimeFigureOut">
              <a:rPr lang="zh-CN" altLang="en-US" smtClean="0"/>
              <a:t>2025/3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5C7B-385F-4B2B-89D4-DBADEA4BF6F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D125-7F42-49FA-BE41-4656495FE582}" type="datetimeFigureOut">
              <a:rPr lang="zh-CN" altLang="en-US" smtClean="0"/>
              <a:t>2025/3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5C7B-385F-4B2B-89D4-DBADEA4BF6F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D125-7F42-49FA-BE41-4656495FE582}" type="datetimeFigureOut">
              <a:rPr lang="zh-CN" altLang="en-US" smtClean="0"/>
              <a:t>2025/3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5C7B-385F-4B2B-89D4-DBADEA4BF6F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D125-7F42-49FA-BE41-4656495FE582}" type="datetimeFigureOut">
              <a:rPr lang="zh-CN" altLang="en-US" smtClean="0"/>
              <a:t>2025/3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5C7B-385F-4B2B-89D4-DBADEA4BF6F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D125-7F42-49FA-BE41-4656495FE582}" type="datetimeFigureOut">
              <a:rPr lang="zh-CN" altLang="en-US" smtClean="0"/>
              <a:t>2025/3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5C7B-385F-4B2B-89D4-DBADEA4BF6F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07D125-7F42-49FA-BE41-4656495FE582}" type="datetimeFigureOut">
              <a:rPr lang="zh-CN" altLang="en-US" smtClean="0"/>
              <a:t>2025/3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945C7B-385F-4B2B-89D4-DBADEA4BF6F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5D439B3-F9EA-25E4-8069-9AC8BDE627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10763"/>
            <a:ext cx="12192000" cy="6055851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7091FD6-D4CC-187B-0CC9-87F563E3055B}"/>
              </a:ext>
            </a:extLst>
          </p:cNvPr>
          <p:cNvSpPr txBox="1"/>
          <p:nvPr/>
        </p:nvSpPr>
        <p:spPr>
          <a:xfrm>
            <a:off x="428979" y="6272259"/>
            <a:ext cx="11763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S1. the hydrogen band network between wild type (WT) chymosin and kappa-casein </a:t>
            </a:r>
          </a:p>
        </p:txBody>
      </p:sp>
    </p:spTree>
    <p:extLst>
      <p:ext uri="{BB962C8B-B14F-4D97-AF65-F5344CB8AC3E}">
        <p14:creationId xmlns:p14="http://schemas.microsoft.com/office/powerpoint/2010/main" val="33582690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272EB9C-A2BF-91F5-B5E0-F319C43BA8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286396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2AE5BDF2-052D-968B-910B-B2DC5EFDA43D}"/>
              </a:ext>
            </a:extLst>
          </p:cNvPr>
          <p:cNvSpPr txBox="1"/>
          <p:nvPr/>
        </p:nvSpPr>
        <p:spPr>
          <a:xfrm>
            <a:off x="225776" y="6327510"/>
            <a:ext cx="11763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S2. the hydrogen band network between chymosin M2 and kappa-casein </a:t>
            </a:r>
          </a:p>
        </p:txBody>
      </p:sp>
    </p:spTree>
    <p:extLst>
      <p:ext uri="{BB962C8B-B14F-4D97-AF65-F5344CB8AC3E}">
        <p14:creationId xmlns:p14="http://schemas.microsoft.com/office/powerpoint/2010/main" val="21818491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73441CF-A207-CE80-862A-3DB5E56DB9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5773"/>
            <a:ext cx="12192000" cy="616716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B11A8639-D5C2-7718-BE2F-7B661525B8BE}"/>
              </a:ext>
            </a:extLst>
          </p:cNvPr>
          <p:cNvSpPr txBox="1"/>
          <p:nvPr/>
        </p:nvSpPr>
        <p:spPr>
          <a:xfrm>
            <a:off x="225778" y="6252933"/>
            <a:ext cx="11763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S3. the hydrogen band network between chymosin M3 and kappa-casein </a:t>
            </a:r>
          </a:p>
        </p:txBody>
      </p:sp>
    </p:spTree>
    <p:extLst>
      <p:ext uri="{BB962C8B-B14F-4D97-AF65-F5344CB8AC3E}">
        <p14:creationId xmlns:p14="http://schemas.microsoft.com/office/powerpoint/2010/main" val="29174349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C242ADD-26A5-D5D2-1AC2-2439A25E4A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4348"/>
            <a:ext cx="12192000" cy="6280321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959742AD-8A57-EBFF-BA3C-50AE6100B2D0}"/>
              </a:ext>
            </a:extLst>
          </p:cNvPr>
          <p:cNvSpPr txBox="1"/>
          <p:nvPr/>
        </p:nvSpPr>
        <p:spPr>
          <a:xfrm>
            <a:off x="225778" y="6286800"/>
            <a:ext cx="11763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S4. the hydrogen band network between chymosin M4 and kappa-casein </a:t>
            </a:r>
          </a:p>
        </p:txBody>
      </p:sp>
    </p:spTree>
    <p:extLst>
      <p:ext uri="{BB962C8B-B14F-4D97-AF65-F5344CB8AC3E}">
        <p14:creationId xmlns:p14="http://schemas.microsoft.com/office/powerpoint/2010/main" val="12046104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F5B19F9-E75E-5488-4693-AFD93BEC06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8267" y="0"/>
            <a:ext cx="10580073" cy="6336013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C4C3B4DE-046B-B265-4518-CB071170B07C}"/>
              </a:ext>
            </a:extLst>
          </p:cNvPr>
          <p:cNvSpPr txBox="1"/>
          <p:nvPr/>
        </p:nvSpPr>
        <p:spPr>
          <a:xfrm>
            <a:off x="225778" y="6286800"/>
            <a:ext cx="11763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S5. the hydrogen band network between chymosin M5 and kappa-casein </a:t>
            </a:r>
          </a:p>
        </p:txBody>
      </p:sp>
    </p:spTree>
    <p:extLst>
      <p:ext uri="{BB962C8B-B14F-4D97-AF65-F5344CB8AC3E}">
        <p14:creationId xmlns:p14="http://schemas.microsoft.com/office/powerpoint/2010/main" val="24238795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40F1FE8-02D9-079C-C517-9A1E6D3ADA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789"/>
            <a:ext cx="12192000" cy="635086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35E62561-9D9F-67AE-52A9-C6CAFF10EE64}"/>
              </a:ext>
            </a:extLst>
          </p:cNvPr>
          <p:cNvSpPr txBox="1"/>
          <p:nvPr/>
        </p:nvSpPr>
        <p:spPr>
          <a:xfrm>
            <a:off x="225778" y="6286800"/>
            <a:ext cx="11763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S6. the hydrogen band network between chymosin M6 and kappa-casein </a:t>
            </a:r>
          </a:p>
        </p:txBody>
      </p:sp>
    </p:spTree>
    <p:extLst>
      <p:ext uri="{BB962C8B-B14F-4D97-AF65-F5344CB8AC3E}">
        <p14:creationId xmlns:p14="http://schemas.microsoft.com/office/powerpoint/2010/main" val="7218071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0BDCB82-1C71-A19F-645A-2D0D631163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6984" y="0"/>
            <a:ext cx="10718031" cy="6196049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DE1B3786-6EEB-0C0F-19BA-7D4543330396}"/>
              </a:ext>
            </a:extLst>
          </p:cNvPr>
          <p:cNvSpPr txBox="1"/>
          <p:nvPr/>
        </p:nvSpPr>
        <p:spPr>
          <a:xfrm>
            <a:off x="225778" y="6286800"/>
            <a:ext cx="11763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S7. the hydrogen band network between chymosin M7 and kappa-casein </a:t>
            </a:r>
          </a:p>
        </p:txBody>
      </p:sp>
    </p:spTree>
    <p:extLst>
      <p:ext uri="{BB962C8B-B14F-4D97-AF65-F5344CB8AC3E}">
        <p14:creationId xmlns:p14="http://schemas.microsoft.com/office/powerpoint/2010/main" val="690462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6</TotalTime>
  <Words>95</Words>
  <Application>Microsoft Macintosh PowerPoint</Application>
  <PresentationFormat>宽屏</PresentationFormat>
  <Paragraphs>7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 zheng</dc:creator>
  <cp:lastModifiedBy>Microsoft Office User</cp:lastModifiedBy>
  <cp:revision>15</cp:revision>
  <dcterms:created xsi:type="dcterms:W3CDTF">2025-02-17T00:45:00Z</dcterms:created>
  <dcterms:modified xsi:type="dcterms:W3CDTF">2025-03-24T12:59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86061F2283046F887C9B32DDD71781E_12</vt:lpwstr>
  </property>
  <property fmtid="{D5CDD505-2E9C-101B-9397-08002B2CF9AE}" pid="3" name="KSOProductBuildVer">
    <vt:lpwstr>2052-12.1.0.20305</vt:lpwstr>
  </property>
</Properties>
</file>